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2" r:id="rId2"/>
  </p:sldIdLst>
  <p:sldSz cx="11699875" cy="14471650"/>
  <p:notesSz cx="6858000" cy="9144000"/>
  <p:defaultTextStyle>
    <a:defPPr>
      <a:defRPr lang="ja-JP"/>
    </a:defPPr>
    <a:lvl1pPr marL="0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1pPr>
    <a:lvl2pPr marL="747695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2pPr>
    <a:lvl3pPr marL="1495390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3pPr>
    <a:lvl4pPr marL="2243085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4pPr>
    <a:lvl5pPr marL="299078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5pPr>
    <a:lvl6pPr marL="3738476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6pPr>
    <a:lvl7pPr marL="448617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7pPr>
    <a:lvl8pPr marL="5233866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8pPr>
    <a:lvl9pPr marL="598156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58" userDrawn="1">
          <p15:clr>
            <a:srgbClr val="A4A3A4"/>
          </p15:clr>
        </p15:guide>
        <p15:guide id="2" pos="36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34" autoAdjust="0"/>
    <p:restoredTop sz="94087" autoAdjust="0"/>
  </p:normalViewPr>
  <p:slideViewPr>
    <p:cSldViewPr snapToGrid="0">
      <p:cViewPr>
        <p:scale>
          <a:sx n="70" d="100"/>
          <a:sy n="70" d="100"/>
        </p:scale>
        <p:origin x="656" y="-2252"/>
      </p:cViewPr>
      <p:guideLst>
        <p:guide orient="horz" pos="4558"/>
        <p:guide pos="36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KIYOHIRO:Desktop:Ohkuma:ANDO191105_data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KIYOHIRO:Desktop:Ohkuma:ANDO191105_data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453252495425381"/>
          <c:y val="0.10270758618069289"/>
          <c:w val="0.72572899405495828"/>
          <c:h val="0.834796503589498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!$H$17:$I$17</c:f>
                <c:numCache>
                  <c:formatCode>General</c:formatCode>
                  <c:ptCount val="2"/>
                  <c:pt idx="0">
                    <c:v>0.168087357470386</c:v>
                  </c:pt>
                  <c:pt idx="1">
                    <c:v>0.12773069886332</c:v>
                  </c:pt>
                </c:numCache>
              </c:numRef>
            </c:plus>
            <c:minus>
              <c:numRef>
                <c:f>グラフ!$H$17:$I$17</c:f>
                <c:numCache>
                  <c:formatCode>General</c:formatCode>
                  <c:ptCount val="2"/>
                  <c:pt idx="0">
                    <c:v>0.168087357470386</c:v>
                  </c:pt>
                  <c:pt idx="1">
                    <c:v>0.12773069886332</c:v>
                  </c:pt>
                </c:numCache>
              </c:numRef>
            </c:minus>
          </c:errBars>
          <c:cat>
            <c:strRef>
              <c:f>グラフ!$H$15:$I$15</c:f>
              <c:strCache>
                <c:ptCount val="2"/>
                <c:pt idx="0">
                  <c:v>SUIT-2_Ctrl Vector</c:v>
                </c:pt>
                <c:pt idx="1">
                  <c:v>SUIT-2_OLFM4</c:v>
                </c:pt>
              </c:strCache>
            </c:strRef>
          </c:cat>
          <c:val>
            <c:numRef>
              <c:f>グラフ!$H$16:$I$16</c:f>
              <c:numCache>
                <c:formatCode>General</c:formatCode>
                <c:ptCount val="2"/>
                <c:pt idx="0">
                  <c:v>1</c:v>
                </c:pt>
                <c:pt idx="1">
                  <c:v>0.12773069886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7F-40B6-BB57-1664A29295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6406184"/>
        <c:axId val="-2126402968"/>
      </c:barChart>
      <c:catAx>
        <c:axId val="-2126406184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-2126402968"/>
        <c:crosses val="autoZero"/>
        <c:auto val="1"/>
        <c:lblAlgn val="ctr"/>
        <c:lblOffset val="100"/>
        <c:noMultiLvlLbl val="0"/>
      </c:catAx>
      <c:valAx>
        <c:axId val="-21264029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 b="1" i="0" baseline="0"/>
            </a:pPr>
            <a:endParaRPr lang="ja-JP"/>
          </a:p>
        </c:txPr>
        <c:crossAx val="-2126406184"/>
        <c:crosses val="autoZero"/>
        <c:crossBetween val="between"/>
      </c:valAx>
      <c:spPr>
        <a:ln w="19050"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  <a:effectLst/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504989295692899"/>
          <c:y val="0.11630562423997932"/>
          <c:w val="0.76504227294168903"/>
          <c:h val="0.727438134663565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50000"/>
                <a:lumOff val="50000"/>
              </a:sys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!$H$7:$I$7</c:f>
                <c:numCache>
                  <c:formatCode>General</c:formatCode>
                  <c:ptCount val="2"/>
                  <c:pt idx="0">
                    <c:v>0.216548917076407</c:v>
                  </c:pt>
                  <c:pt idx="1">
                    <c:v>7.2670037374688107E-2</c:v>
                  </c:pt>
                </c:numCache>
              </c:numRef>
            </c:plus>
            <c:minus>
              <c:numRef>
                <c:f>グラフ!$H$7:$I$7</c:f>
                <c:numCache>
                  <c:formatCode>General</c:formatCode>
                  <c:ptCount val="2"/>
                  <c:pt idx="0">
                    <c:v>0.216548917076407</c:v>
                  </c:pt>
                  <c:pt idx="1">
                    <c:v>7.2670037374688107E-2</c:v>
                  </c:pt>
                </c:numCache>
              </c:numRef>
            </c:minus>
          </c:errBars>
          <c:cat>
            <c:strRef>
              <c:f>グラフ!$H$5:$I$5</c:f>
              <c:strCache>
                <c:ptCount val="2"/>
                <c:pt idx="0">
                  <c:v>KP-2_Ctrl Vector</c:v>
                </c:pt>
                <c:pt idx="1">
                  <c:v>KP-2_OLFM4</c:v>
                </c:pt>
              </c:strCache>
            </c:strRef>
          </c:cat>
          <c:val>
            <c:numRef>
              <c:f>グラフ!$H$6:$I$6</c:f>
              <c:numCache>
                <c:formatCode>General</c:formatCode>
                <c:ptCount val="2"/>
                <c:pt idx="0">
                  <c:v>1</c:v>
                </c:pt>
                <c:pt idx="1">
                  <c:v>0.82648314196871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A3-4403-9B25-E89EB5CD5D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2327400"/>
        <c:axId val="-2132348008"/>
      </c:barChart>
      <c:catAx>
        <c:axId val="-2132327400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-2132348008"/>
        <c:crosses val="autoZero"/>
        <c:auto val="1"/>
        <c:lblAlgn val="ctr"/>
        <c:lblOffset val="100"/>
        <c:noMultiLvlLbl val="0"/>
      </c:catAx>
      <c:valAx>
        <c:axId val="-2132348008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/>
            </a:pPr>
            <a:endParaRPr lang="ja-JP"/>
          </a:p>
        </c:txPr>
        <c:crossAx val="-2132327400"/>
        <c:crosses val="autoZero"/>
        <c:crossBetween val="between"/>
        <c:majorUnit val="0.5"/>
      </c:valAx>
      <c:spPr>
        <a:ln w="19050"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 w="31750">
      <a:noFill/>
    </a:ln>
  </c:spPr>
  <c:txPr>
    <a:bodyPr/>
    <a:lstStyle/>
    <a:p>
      <a:pPr>
        <a:defRPr sz="1400" b="1" i="0" baseline="0"/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60109870591434"/>
          <c:y val="0.15972989343068084"/>
          <c:w val="0.78570815266389038"/>
          <c:h val="0.659742662104866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LFM4!$G$2:$G$11</c:f>
                <c:numCache>
                  <c:formatCode>General</c:formatCode>
                  <c:ptCount val="5"/>
                  <c:pt idx="0">
                    <c:v>8.3812613677421252E-2</c:v>
                  </c:pt>
                  <c:pt idx="1">
                    <c:v>5.3491263113840601E-2</c:v>
                  </c:pt>
                  <c:pt idx="2">
                    <c:v>7.5797753540299245E-2</c:v>
                  </c:pt>
                  <c:pt idx="3">
                    <c:v>0.11339631767449272</c:v>
                  </c:pt>
                  <c:pt idx="4">
                    <c:v>0.15404357080539643</c:v>
                  </c:pt>
                </c:numCache>
              </c:numRef>
            </c:plus>
            <c:minus>
              <c:numRef>
                <c:f>OLFM4!$G$2:$G$11</c:f>
                <c:numCache>
                  <c:formatCode>General</c:formatCode>
                  <c:ptCount val="5"/>
                  <c:pt idx="0">
                    <c:v>8.3812613677421252E-2</c:v>
                  </c:pt>
                  <c:pt idx="1">
                    <c:v>5.3491263113840601E-2</c:v>
                  </c:pt>
                  <c:pt idx="2">
                    <c:v>7.5797753540299245E-2</c:v>
                  </c:pt>
                  <c:pt idx="3">
                    <c:v>0.11339631767449272</c:v>
                  </c:pt>
                  <c:pt idx="4">
                    <c:v>0.154043570805396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LFM4!$A$2:$A$11</c:f>
              <c:strCache>
                <c:ptCount val="5"/>
                <c:pt idx="0">
                  <c:v>HeLa</c:v>
                </c:pt>
                <c:pt idx="1">
                  <c:v>PANC-1</c:v>
                </c:pt>
                <c:pt idx="2">
                  <c:v>KP2</c:v>
                </c:pt>
                <c:pt idx="3">
                  <c:v>MIA PaCa-2</c:v>
                </c:pt>
                <c:pt idx="4">
                  <c:v>SUIT-2</c:v>
                </c:pt>
              </c:strCache>
            </c:strRef>
          </c:cat>
          <c:val>
            <c:numRef>
              <c:f>OLFM4!$C$3:$C$11</c:f>
              <c:numCache>
                <c:formatCode>General</c:formatCode>
                <c:ptCount val="5"/>
                <c:pt idx="0">
                  <c:v>1</c:v>
                </c:pt>
                <c:pt idx="1">
                  <c:v>0.67232800000000004</c:v>
                </c:pt>
                <c:pt idx="2">
                  <c:v>1.7273529999999999</c:v>
                </c:pt>
                <c:pt idx="3">
                  <c:v>0.109102</c:v>
                </c:pt>
                <c:pt idx="4">
                  <c:v>2.122281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69-4336-9290-7DD1F6C22F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559760"/>
        <c:axId val="399560080"/>
      </c:barChart>
      <c:catAx>
        <c:axId val="399559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99560080"/>
        <c:crosses val="autoZero"/>
        <c:auto val="1"/>
        <c:lblAlgn val="ctr"/>
        <c:lblOffset val="100"/>
        <c:noMultiLvlLbl val="0"/>
      </c:catAx>
      <c:valAx>
        <c:axId val="399560080"/>
        <c:scaling>
          <c:orientation val="minMax"/>
          <c:max val="2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4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en-US" altLang="ja-JP" sz="1600" b="1" i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OLFM4</a:t>
                </a:r>
                <a:r>
                  <a:rPr lang="en-US" altLang="ja-JP" sz="16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 gene expression </a:t>
                </a:r>
              </a:p>
              <a:p>
                <a:pPr>
                  <a:defRPr sz="1400" b="1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defRPr>
                </a:pPr>
                <a:r>
                  <a:rPr lang="en-US" altLang="ja-JP" sz="16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(relative to HeLa)</a:t>
                </a:r>
              </a:p>
            </c:rich>
          </c:tx>
          <c:layout>
            <c:manualLayout>
              <c:xMode val="edge"/>
              <c:yMode val="edge"/>
              <c:x val="1.1293471151393626E-2"/>
              <c:y val="0.199314093014880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99559760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AD3E61-EC32-483D-9DDF-57D11B031888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1143000"/>
            <a:ext cx="2492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4B1162-AEBC-4D44-87BC-B2984C296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129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1pPr>
    <a:lvl2pPr marL="747695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2pPr>
    <a:lvl3pPr marL="1495390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3pPr>
    <a:lvl4pPr marL="2243085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4pPr>
    <a:lvl5pPr marL="299078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5pPr>
    <a:lvl6pPr marL="3738476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6pPr>
    <a:lvl7pPr marL="448617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7pPr>
    <a:lvl8pPr marL="5233866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8pPr>
    <a:lvl9pPr marL="598156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77491" y="2368394"/>
            <a:ext cx="9944894" cy="5038278"/>
          </a:xfrm>
        </p:spPr>
        <p:txBody>
          <a:bodyPr anchor="b"/>
          <a:lstStyle>
            <a:lvl1pPr algn="ctr">
              <a:defRPr sz="767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2485" y="7600967"/>
            <a:ext cx="8774906" cy="3493964"/>
          </a:xfrm>
        </p:spPr>
        <p:txBody>
          <a:bodyPr/>
          <a:lstStyle>
            <a:lvl1pPr marL="0" indent="0" algn="ctr">
              <a:buNone/>
              <a:defRPr sz="3071"/>
            </a:lvl1pPr>
            <a:lvl2pPr marL="584987" indent="0" algn="ctr">
              <a:buNone/>
              <a:defRPr sz="2559"/>
            </a:lvl2pPr>
            <a:lvl3pPr marL="1169975" indent="0" algn="ctr">
              <a:buNone/>
              <a:defRPr sz="2303"/>
            </a:lvl3pPr>
            <a:lvl4pPr marL="1754962" indent="0" algn="ctr">
              <a:buNone/>
              <a:defRPr sz="2047"/>
            </a:lvl4pPr>
            <a:lvl5pPr marL="2339950" indent="0" algn="ctr">
              <a:buNone/>
              <a:defRPr sz="2047"/>
            </a:lvl5pPr>
            <a:lvl6pPr marL="2924937" indent="0" algn="ctr">
              <a:buNone/>
              <a:defRPr sz="2047"/>
            </a:lvl6pPr>
            <a:lvl7pPr marL="3509924" indent="0" algn="ctr">
              <a:buNone/>
              <a:defRPr sz="2047"/>
            </a:lvl7pPr>
            <a:lvl8pPr marL="4094912" indent="0" algn="ctr">
              <a:buNone/>
              <a:defRPr sz="2047"/>
            </a:lvl8pPr>
            <a:lvl9pPr marL="4679899" indent="0" algn="ctr">
              <a:buNone/>
              <a:defRPr sz="2047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367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582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72723" y="770482"/>
            <a:ext cx="2522786" cy="1226405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4367" y="770482"/>
            <a:ext cx="7422108" cy="1226405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162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319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8273" y="3607867"/>
            <a:ext cx="10091142" cy="6019803"/>
          </a:xfrm>
        </p:spPr>
        <p:txBody>
          <a:bodyPr anchor="b"/>
          <a:lstStyle>
            <a:lvl1pPr>
              <a:defRPr sz="767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8273" y="9684620"/>
            <a:ext cx="10091142" cy="3165672"/>
          </a:xfrm>
        </p:spPr>
        <p:txBody>
          <a:bodyPr/>
          <a:lstStyle>
            <a:lvl1pPr marL="0" indent="0">
              <a:buNone/>
              <a:defRPr sz="3071">
                <a:solidFill>
                  <a:schemeClr val="tx1"/>
                </a:solidFill>
              </a:defRPr>
            </a:lvl1pPr>
            <a:lvl2pPr marL="584987" indent="0">
              <a:buNone/>
              <a:defRPr sz="2559">
                <a:solidFill>
                  <a:schemeClr val="tx1">
                    <a:tint val="75000"/>
                  </a:schemeClr>
                </a:solidFill>
              </a:defRPr>
            </a:lvl2pPr>
            <a:lvl3pPr marL="1169975" indent="0">
              <a:buNone/>
              <a:defRPr sz="2303">
                <a:solidFill>
                  <a:schemeClr val="tx1">
                    <a:tint val="75000"/>
                  </a:schemeClr>
                </a:solidFill>
              </a:defRPr>
            </a:lvl3pPr>
            <a:lvl4pPr marL="1754962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4pPr>
            <a:lvl5pPr marL="2339950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5pPr>
            <a:lvl6pPr marL="2924937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6pPr>
            <a:lvl7pPr marL="3509924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7pPr>
            <a:lvl8pPr marL="4094912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8pPr>
            <a:lvl9pPr marL="4679899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044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04366" y="3852407"/>
            <a:ext cx="4972447" cy="918212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23062" y="3852407"/>
            <a:ext cx="4972447" cy="918212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9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770485"/>
            <a:ext cx="10091142" cy="279718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5891" y="3547565"/>
            <a:ext cx="4949595" cy="1738607"/>
          </a:xfrm>
        </p:spPr>
        <p:txBody>
          <a:bodyPr anchor="b"/>
          <a:lstStyle>
            <a:lvl1pPr marL="0" indent="0">
              <a:buNone/>
              <a:defRPr sz="3071" b="1"/>
            </a:lvl1pPr>
            <a:lvl2pPr marL="584987" indent="0">
              <a:buNone/>
              <a:defRPr sz="2559" b="1"/>
            </a:lvl2pPr>
            <a:lvl3pPr marL="1169975" indent="0">
              <a:buNone/>
              <a:defRPr sz="2303" b="1"/>
            </a:lvl3pPr>
            <a:lvl4pPr marL="1754962" indent="0">
              <a:buNone/>
              <a:defRPr sz="2047" b="1"/>
            </a:lvl4pPr>
            <a:lvl5pPr marL="2339950" indent="0">
              <a:buNone/>
              <a:defRPr sz="2047" b="1"/>
            </a:lvl5pPr>
            <a:lvl6pPr marL="2924937" indent="0">
              <a:buNone/>
              <a:defRPr sz="2047" b="1"/>
            </a:lvl6pPr>
            <a:lvl7pPr marL="3509924" indent="0">
              <a:buNone/>
              <a:defRPr sz="2047" b="1"/>
            </a:lvl7pPr>
            <a:lvl8pPr marL="4094912" indent="0">
              <a:buNone/>
              <a:defRPr sz="2047" b="1"/>
            </a:lvl8pPr>
            <a:lvl9pPr marL="4679899" indent="0">
              <a:buNone/>
              <a:defRPr sz="2047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5891" y="5286172"/>
            <a:ext cx="4949595" cy="777516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923062" y="3547565"/>
            <a:ext cx="4973971" cy="1738607"/>
          </a:xfrm>
        </p:spPr>
        <p:txBody>
          <a:bodyPr anchor="b"/>
          <a:lstStyle>
            <a:lvl1pPr marL="0" indent="0">
              <a:buNone/>
              <a:defRPr sz="3071" b="1"/>
            </a:lvl1pPr>
            <a:lvl2pPr marL="584987" indent="0">
              <a:buNone/>
              <a:defRPr sz="2559" b="1"/>
            </a:lvl2pPr>
            <a:lvl3pPr marL="1169975" indent="0">
              <a:buNone/>
              <a:defRPr sz="2303" b="1"/>
            </a:lvl3pPr>
            <a:lvl4pPr marL="1754962" indent="0">
              <a:buNone/>
              <a:defRPr sz="2047" b="1"/>
            </a:lvl4pPr>
            <a:lvl5pPr marL="2339950" indent="0">
              <a:buNone/>
              <a:defRPr sz="2047" b="1"/>
            </a:lvl5pPr>
            <a:lvl6pPr marL="2924937" indent="0">
              <a:buNone/>
              <a:defRPr sz="2047" b="1"/>
            </a:lvl6pPr>
            <a:lvl7pPr marL="3509924" indent="0">
              <a:buNone/>
              <a:defRPr sz="2047" b="1"/>
            </a:lvl7pPr>
            <a:lvl8pPr marL="4094912" indent="0">
              <a:buNone/>
              <a:defRPr sz="2047" b="1"/>
            </a:lvl8pPr>
            <a:lvl9pPr marL="4679899" indent="0">
              <a:buNone/>
              <a:defRPr sz="2047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923062" y="5286172"/>
            <a:ext cx="4973971" cy="777516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130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782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019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964777"/>
            <a:ext cx="3773514" cy="3376718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73971" y="2083653"/>
            <a:ext cx="5923062" cy="10284251"/>
          </a:xfrm>
        </p:spPr>
        <p:txBody>
          <a:bodyPr/>
          <a:lstStyle>
            <a:lvl1pPr>
              <a:defRPr sz="4094"/>
            </a:lvl1pPr>
            <a:lvl2pPr>
              <a:defRPr sz="3583"/>
            </a:lvl2pPr>
            <a:lvl3pPr>
              <a:defRPr sz="3071"/>
            </a:lvl3pPr>
            <a:lvl4pPr>
              <a:defRPr sz="2559"/>
            </a:lvl4pPr>
            <a:lvl5pPr>
              <a:defRPr sz="2559"/>
            </a:lvl5pPr>
            <a:lvl6pPr>
              <a:defRPr sz="2559"/>
            </a:lvl6pPr>
            <a:lvl7pPr>
              <a:defRPr sz="2559"/>
            </a:lvl7pPr>
            <a:lvl8pPr>
              <a:defRPr sz="2559"/>
            </a:lvl8pPr>
            <a:lvl9pPr>
              <a:defRPr sz="255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5890" y="4341495"/>
            <a:ext cx="3773514" cy="8043157"/>
          </a:xfrm>
        </p:spPr>
        <p:txBody>
          <a:bodyPr/>
          <a:lstStyle>
            <a:lvl1pPr marL="0" indent="0">
              <a:buNone/>
              <a:defRPr sz="2047"/>
            </a:lvl1pPr>
            <a:lvl2pPr marL="584987" indent="0">
              <a:buNone/>
              <a:defRPr sz="1791"/>
            </a:lvl2pPr>
            <a:lvl3pPr marL="1169975" indent="0">
              <a:buNone/>
              <a:defRPr sz="1535"/>
            </a:lvl3pPr>
            <a:lvl4pPr marL="1754962" indent="0">
              <a:buNone/>
              <a:defRPr sz="1280"/>
            </a:lvl4pPr>
            <a:lvl5pPr marL="2339950" indent="0">
              <a:buNone/>
              <a:defRPr sz="1280"/>
            </a:lvl5pPr>
            <a:lvl6pPr marL="2924937" indent="0">
              <a:buNone/>
              <a:defRPr sz="1280"/>
            </a:lvl6pPr>
            <a:lvl7pPr marL="3509924" indent="0">
              <a:buNone/>
              <a:defRPr sz="1280"/>
            </a:lvl7pPr>
            <a:lvl8pPr marL="4094912" indent="0">
              <a:buNone/>
              <a:defRPr sz="1280"/>
            </a:lvl8pPr>
            <a:lvl9pPr marL="4679899" indent="0">
              <a:buNone/>
              <a:defRPr sz="12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682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964777"/>
            <a:ext cx="3773514" cy="3376718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973971" y="2083653"/>
            <a:ext cx="5923062" cy="10284251"/>
          </a:xfrm>
        </p:spPr>
        <p:txBody>
          <a:bodyPr anchor="t"/>
          <a:lstStyle>
            <a:lvl1pPr marL="0" indent="0">
              <a:buNone/>
              <a:defRPr sz="4094"/>
            </a:lvl1pPr>
            <a:lvl2pPr marL="584987" indent="0">
              <a:buNone/>
              <a:defRPr sz="3583"/>
            </a:lvl2pPr>
            <a:lvl3pPr marL="1169975" indent="0">
              <a:buNone/>
              <a:defRPr sz="3071"/>
            </a:lvl3pPr>
            <a:lvl4pPr marL="1754962" indent="0">
              <a:buNone/>
              <a:defRPr sz="2559"/>
            </a:lvl4pPr>
            <a:lvl5pPr marL="2339950" indent="0">
              <a:buNone/>
              <a:defRPr sz="2559"/>
            </a:lvl5pPr>
            <a:lvl6pPr marL="2924937" indent="0">
              <a:buNone/>
              <a:defRPr sz="2559"/>
            </a:lvl6pPr>
            <a:lvl7pPr marL="3509924" indent="0">
              <a:buNone/>
              <a:defRPr sz="2559"/>
            </a:lvl7pPr>
            <a:lvl8pPr marL="4094912" indent="0">
              <a:buNone/>
              <a:defRPr sz="2559"/>
            </a:lvl8pPr>
            <a:lvl9pPr marL="4679899" indent="0">
              <a:buNone/>
              <a:defRPr sz="255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5890" y="4341495"/>
            <a:ext cx="3773514" cy="8043157"/>
          </a:xfrm>
        </p:spPr>
        <p:txBody>
          <a:bodyPr/>
          <a:lstStyle>
            <a:lvl1pPr marL="0" indent="0">
              <a:buNone/>
              <a:defRPr sz="2047"/>
            </a:lvl1pPr>
            <a:lvl2pPr marL="584987" indent="0">
              <a:buNone/>
              <a:defRPr sz="1791"/>
            </a:lvl2pPr>
            <a:lvl3pPr marL="1169975" indent="0">
              <a:buNone/>
              <a:defRPr sz="1535"/>
            </a:lvl3pPr>
            <a:lvl4pPr marL="1754962" indent="0">
              <a:buNone/>
              <a:defRPr sz="1280"/>
            </a:lvl4pPr>
            <a:lvl5pPr marL="2339950" indent="0">
              <a:buNone/>
              <a:defRPr sz="1280"/>
            </a:lvl5pPr>
            <a:lvl6pPr marL="2924937" indent="0">
              <a:buNone/>
              <a:defRPr sz="1280"/>
            </a:lvl6pPr>
            <a:lvl7pPr marL="3509924" indent="0">
              <a:buNone/>
              <a:defRPr sz="1280"/>
            </a:lvl7pPr>
            <a:lvl8pPr marL="4094912" indent="0">
              <a:buNone/>
              <a:defRPr sz="1280"/>
            </a:lvl8pPr>
            <a:lvl9pPr marL="4679899" indent="0">
              <a:buNone/>
              <a:defRPr sz="12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90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04367" y="770485"/>
            <a:ext cx="10091142" cy="27971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4367" y="3852407"/>
            <a:ext cx="10091142" cy="91821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04366" y="13413079"/>
            <a:ext cx="2632472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BB0E7-E129-40C4-85C7-B72E3E7E807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75584" y="13413079"/>
            <a:ext cx="3948708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63037" y="13413079"/>
            <a:ext cx="2632472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994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169975" rtl="0" eaLnBrk="1" latinLnBrk="0" hangingPunct="1">
        <a:lnSpc>
          <a:spcPct val="90000"/>
        </a:lnSpc>
        <a:spcBef>
          <a:spcPct val="0"/>
        </a:spcBef>
        <a:buNone/>
        <a:defRPr kumimoji="1" sz="5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2494" indent="-292494" algn="l" defTabSz="1169975" rtl="0" eaLnBrk="1" latinLnBrk="0" hangingPunct="1">
        <a:lnSpc>
          <a:spcPct val="90000"/>
        </a:lnSpc>
        <a:spcBef>
          <a:spcPts val="1280"/>
        </a:spcBef>
        <a:buFont typeface="Arial" panose="020B0604020202020204" pitchFamily="34" charset="0"/>
        <a:buChar char="•"/>
        <a:defRPr kumimoji="1" sz="3583" kern="1200">
          <a:solidFill>
            <a:schemeClr val="tx1"/>
          </a:solidFill>
          <a:latin typeface="+mn-lt"/>
          <a:ea typeface="+mn-ea"/>
          <a:cs typeface="+mn-cs"/>
        </a:defRPr>
      </a:lvl1pPr>
      <a:lvl2pPr marL="877481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3071" kern="1200">
          <a:solidFill>
            <a:schemeClr val="tx1"/>
          </a:solidFill>
          <a:latin typeface="+mn-lt"/>
          <a:ea typeface="+mn-ea"/>
          <a:cs typeface="+mn-cs"/>
        </a:defRPr>
      </a:lvl2pPr>
      <a:lvl3pPr marL="1462469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559" kern="1200">
          <a:solidFill>
            <a:schemeClr val="tx1"/>
          </a:solidFill>
          <a:latin typeface="+mn-lt"/>
          <a:ea typeface="+mn-ea"/>
          <a:cs typeface="+mn-cs"/>
        </a:defRPr>
      </a:lvl3pPr>
      <a:lvl4pPr marL="2047456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4pPr>
      <a:lvl5pPr marL="2632443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5pPr>
      <a:lvl6pPr marL="3217431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6pPr>
      <a:lvl7pPr marL="3802418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7pPr>
      <a:lvl8pPr marL="4387406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8pPr>
      <a:lvl9pPr marL="4972393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1pPr>
      <a:lvl2pPr marL="584987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3pPr>
      <a:lvl4pPr marL="1754962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4pPr>
      <a:lvl5pPr marL="2339950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5pPr>
      <a:lvl6pPr marL="2924937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6pPr>
      <a:lvl7pPr marL="3509924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7pPr>
      <a:lvl8pPr marL="4094912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8pPr>
      <a:lvl9pPr marL="4679899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22842" y="9104824"/>
            <a:ext cx="9854190" cy="3002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Reverse-Transcription PCR and Immunoblotting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Quantitative Reverse-Transcription PCR. We measured the level of OLFM4 gene expression in HeLa cells and four pancreatic cancer cell lines (PANC-1, KP2, MIA PaCa-2, and SUIT-2) by real-time RT-PCR and found that endogenous OLFM4 expression was relatively lower in HeLa, PANC-1, and MIA-PaCa-2 cells than in KP2 and SUIT-2 cells. (b) Quantitative Reverse-Transcription PCR for KP2 and SUIT-2 cells. KP2 and SUIT-2 cell lines were transfected siRNA to knockdown OLFM4, SUIT-2 cell showed the knockdown efficiency of OLFM4, but not KP2 cells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; overexpression. (c) Immunoblotting. It was confirmed that OLFM4 overexpression was not observed in PANC-1 cells, while the OLFM4 was overexpressed in MIA PaCa-2 cells. 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8FD5999B-6666-49C7-BB3C-501B8A05A857}"/>
              </a:ext>
            </a:extLst>
          </p:cNvPr>
          <p:cNvGrpSpPr/>
          <p:nvPr/>
        </p:nvGrpSpPr>
        <p:grpSpPr>
          <a:xfrm>
            <a:off x="6697485" y="5536722"/>
            <a:ext cx="3867150" cy="2440918"/>
            <a:chOff x="4371683" y="1745475"/>
            <a:chExt cx="3867150" cy="2440918"/>
          </a:xfrm>
        </p:grpSpPr>
        <p:pic>
          <p:nvPicPr>
            <p:cNvPr id="137" name="図 2" descr="Bio-Rad 2019-10-30 11hr 32min_Exposure_27.0sec.tif">
              <a:extLst>
                <a:ext uri="{FF2B5EF4-FFF2-40B4-BE49-F238E27FC236}">
                  <a16:creationId xmlns:a16="http://schemas.microsoft.com/office/drawing/2014/main" id="{167C678B-8CA1-415D-93A9-AF3F05767D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68" t="56955" r="32303" b="32220"/>
            <a:stretch>
              <a:fillRect/>
            </a:stretch>
          </p:blipFill>
          <p:spPr bwMode="auto">
            <a:xfrm>
              <a:off x="4371683" y="2968781"/>
              <a:ext cx="2682875" cy="53816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38" name="直線矢印コネクタ 137">
              <a:extLst>
                <a:ext uri="{FF2B5EF4-FFF2-40B4-BE49-F238E27FC236}">
                  <a16:creationId xmlns:a16="http://schemas.microsoft.com/office/drawing/2014/main" id="{B2EC9993-C2F5-49D7-961C-D3E60361994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199019" y="3221193"/>
              <a:ext cx="134938" cy="0"/>
            </a:xfrm>
            <a:prstGeom prst="straightConnector1">
              <a:avLst/>
            </a:prstGeom>
            <a:noFill/>
            <a:ln w="57150">
              <a:solidFill>
                <a:schemeClr val="tx1"/>
              </a:solidFill>
              <a:round/>
              <a:headEnd type="triangle" w="med" len="med"/>
              <a:tailEnd/>
            </a:ln>
            <a:effectLst>
              <a:outerShdw blurRad="40000" dist="20000" dir="5400000" rotWithShape="0">
                <a:srgbClr val="808080">
                  <a:alpha val="37999"/>
                </a:srgbClr>
              </a:outerShdw>
            </a:effectLst>
          </p:spPr>
        </p:cxnSp>
        <p:sp>
          <p:nvSpPr>
            <p:cNvPr id="139" name="テキスト ボックス 7">
              <a:extLst>
                <a:ext uri="{FF2B5EF4-FFF2-40B4-BE49-F238E27FC236}">
                  <a16:creationId xmlns:a16="http://schemas.microsoft.com/office/drawing/2014/main" id="{24EF2523-F011-47E8-AB99-9A9E01CCB6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84758" y="3019580"/>
              <a:ext cx="85407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/>
                <a:t>OLFM4</a:t>
              </a:r>
              <a:endParaRPr lang="ja-JP" altLang="en-US" sz="1800"/>
            </a:p>
          </p:txBody>
        </p:sp>
        <p:cxnSp>
          <p:nvCxnSpPr>
            <p:cNvPr id="140" name="直線矢印コネクタ 139">
              <a:extLst>
                <a:ext uri="{FF2B5EF4-FFF2-40B4-BE49-F238E27FC236}">
                  <a16:creationId xmlns:a16="http://schemas.microsoft.com/office/drawing/2014/main" id="{66CEB81B-D6A9-489B-8D8F-FF87A0AEAC9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214895" y="3865718"/>
              <a:ext cx="136525" cy="0"/>
            </a:xfrm>
            <a:prstGeom prst="straightConnector1">
              <a:avLst/>
            </a:prstGeom>
            <a:noFill/>
            <a:ln w="57150">
              <a:solidFill>
                <a:schemeClr val="tx1"/>
              </a:solidFill>
              <a:round/>
              <a:headEnd type="triangle" w="med" len="med"/>
              <a:tailEnd/>
            </a:ln>
            <a:effectLst>
              <a:outerShdw blurRad="40000" dist="20000" dir="5400000" rotWithShape="0">
                <a:srgbClr val="808080">
                  <a:alpha val="37999"/>
                </a:srgbClr>
              </a:outerShdw>
            </a:effectLst>
          </p:spPr>
        </p:cxnSp>
        <p:sp>
          <p:nvSpPr>
            <p:cNvPr id="141" name="テキスト ボックス 7">
              <a:extLst>
                <a:ext uri="{FF2B5EF4-FFF2-40B4-BE49-F238E27FC236}">
                  <a16:creationId xmlns:a16="http://schemas.microsoft.com/office/drawing/2014/main" id="{A1B1F69C-2F7D-4127-838A-C1572E6EC6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02220" y="3665693"/>
              <a:ext cx="665163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/>
                <a:t>Actin</a:t>
              </a:r>
              <a:endParaRPr lang="ja-JP" altLang="en-US" sz="1800"/>
            </a:p>
          </p:txBody>
        </p:sp>
        <p:sp>
          <p:nvSpPr>
            <p:cNvPr id="142" name="テキスト ボックス 5">
              <a:extLst>
                <a:ext uri="{FF2B5EF4-FFF2-40B4-BE49-F238E27FC236}">
                  <a16:creationId xmlns:a16="http://schemas.microsoft.com/office/drawing/2014/main" id="{4C45D98A-3241-4E8E-A00D-8B31819F3B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27303" y="1745475"/>
              <a:ext cx="89357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 b="1" dirty="0"/>
                <a:t>PANC-1</a:t>
              </a:r>
              <a:endParaRPr lang="ja-JP" altLang="en-US" sz="1800" b="1" dirty="0"/>
            </a:p>
          </p:txBody>
        </p:sp>
        <p:sp>
          <p:nvSpPr>
            <p:cNvPr id="143" name="テキスト ボックス 7">
              <a:extLst>
                <a:ext uri="{FF2B5EF4-FFF2-40B4-BE49-F238E27FC236}">
                  <a16:creationId xmlns:a16="http://schemas.microsoft.com/office/drawing/2014/main" id="{382AFCF0-2D52-446C-B400-B6C15DBE6E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62426" y="1745475"/>
              <a:ext cx="129586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 b="1" dirty="0"/>
                <a:t>MIA PaCa-2</a:t>
              </a:r>
              <a:endParaRPr lang="ja-JP" altLang="en-US" sz="1800" b="1" dirty="0"/>
            </a:p>
          </p:txBody>
        </p:sp>
        <p:sp>
          <p:nvSpPr>
            <p:cNvPr id="144" name="テキスト ボックス 6">
              <a:extLst>
                <a:ext uri="{FF2B5EF4-FFF2-40B4-BE49-F238E27FC236}">
                  <a16:creationId xmlns:a16="http://schemas.microsoft.com/office/drawing/2014/main" id="{81C34657-0A1A-44A8-BBF2-6B27F3164D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107489" y="2367913"/>
              <a:ext cx="58102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/>
                <a:t>OVE</a:t>
              </a:r>
              <a:endParaRPr lang="ja-JP" altLang="en-US" sz="1800"/>
            </a:p>
          </p:txBody>
        </p:sp>
        <p:sp>
          <p:nvSpPr>
            <p:cNvPr id="145" name="テキスト ボックス 12">
              <a:extLst>
                <a:ext uri="{FF2B5EF4-FFF2-40B4-BE49-F238E27FC236}">
                  <a16:creationId xmlns:a16="http://schemas.microsoft.com/office/drawing/2014/main" id="{80EE5BB0-3954-4EBF-ABB2-0543A13557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250489" y="2367913"/>
              <a:ext cx="58102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 dirty="0"/>
                <a:t>OVE</a:t>
              </a:r>
              <a:endParaRPr lang="ja-JP" altLang="en-US" sz="1800" dirty="0"/>
            </a:p>
          </p:txBody>
        </p: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75D88531-CEDC-48D9-8BE4-E1A6EDCEEC5F}"/>
                </a:ext>
              </a:extLst>
            </p:cNvPr>
            <p:cNvCxnSpPr/>
            <p:nvPr/>
          </p:nvCxnSpPr>
          <p:spPr>
            <a:xfrm>
              <a:off x="5786144" y="2163918"/>
              <a:ext cx="102393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9B186FF2-71B1-461A-A74A-3ECD0003A424}"/>
                </a:ext>
              </a:extLst>
            </p:cNvPr>
            <p:cNvCxnSpPr/>
            <p:nvPr/>
          </p:nvCxnSpPr>
          <p:spPr>
            <a:xfrm>
              <a:off x="4576470" y="2163918"/>
              <a:ext cx="981075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テキスト ボックス 12">
              <a:extLst>
                <a:ext uri="{FF2B5EF4-FFF2-40B4-BE49-F238E27FC236}">
                  <a16:creationId xmlns:a16="http://schemas.microsoft.com/office/drawing/2014/main" id="{2F412118-2EE8-4B22-A3A5-C2DE8E15B3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44076" y="2412362"/>
              <a:ext cx="45402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/>
                <a:t>NT</a:t>
              </a:r>
              <a:endParaRPr lang="ja-JP" altLang="en-US" sz="1800"/>
            </a:p>
          </p:txBody>
        </p:sp>
        <p:sp>
          <p:nvSpPr>
            <p:cNvPr id="149" name="テキスト ボックス 12">
              <a:extLst>
                <a:ext uri="{FF2B5EF4-FFF2-40B4-BE49-F238E27FC236}">
                  <a16:creationId xmlns:a16="http://schemas.microsoft.com/office/drawing/2014/main" id="{0A23EF42-37C0-41F7-9D65-8023AA8044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593139" y="2445700"/>
              <a:ext cx="45402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/>
                <a:t>NT</a:t>
              </a:r>
              <a:endParaRPr lang="ja-JP" altLang="en-US" sz="1800"/>
            </a:p>
          </p:txBody>
        </p:sp>
        <p:pic>
          <p:nvPicPr>
            <p:cNvPr id="150" name="図 18" descr="Bio-Rad 2019-11-06 13hr 31min_Exposure_3.2sec.tif">
              <a:extLst>
                <a:ext uri="{FF2B5EF4-FFF2-40B4-BE49-F238E27FC236}">
                  <a16:creationId xmlns:a16="http://schemas.microsoft.com/office/drawing/2014/main" id="{69DE6A46-2C58-464C-93F0-EC51F1F7AA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44" t="53694" r="28317" b="33330"/>
            <a:stretch>
              <a:fillRect/>
            </a:stretch>
          </p:blipFill>
          <p:spPr bwMode="auto">
            <a:xfrm>
              <a:off x="4371683" y="3645055"/>
              <a:ext cx="2682875" cy="54133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2C729190-D93B-4C92-8377-43F6BE8929B5}"/>
              </a:ext>
            </a:extLst>
          </p:cNvPr>
          <p:cNvGrpSpPr/>
          <p:nvPr/>
        </p:nvGrpSpPr>
        <p:grpSpPr>
          <a:xfrm>
            <a:off x="3340048" y="5478587"/>
            <a:ext cx="2037328" cy="2499053"/>
            <a:chOff x="5963533" y="568776"/>
            <a:chExt cx="2037328" cy="2499053"/>
          </a:xfrm>
        </p:grpSpPr>
        <p:sp>
          <p:nvSpPr>
            <p:cNvPr id="152" name="テキスト ボックス 7">
              <a:extLst>
                <a:ext uri="{FF2B5EF4-FFF2-40B4-BE49-F238E27FC236}">
                  <a16:creationId xmlns:a16="http://schemas.microsoft.com/office/drawing/2014/main" id="{78A4982C-67BC-44B9-9212-D2B55EBF86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64158" y="568776"/>
              <a:ext cx="806631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 b="1" dirty="0"/>
                <a:t>SUIT-2</a:t>
              </a:r>
              <a:endParaRPr lang="ja-JP" altLang="en-US" sz="1800" b="1" dirty="0"/>
            </a:p>
          </p:txBody>
        </p:sp>
        <p:graphicFrame>
          <p:nvGraphicFramePr>
            <p:cNvPr id="153" name="グラフ 152">
              <a:extLst>
                <a:ext uri="{FF2B5EF4-FFF2-40B4-BE49-F238E27FC236}">
                  <a16:creationId xmlns:a16="http://schemas.microsoft.com/office/drawing/2014/main" id="{F628824E-A87F-4C79-AD2F-6D21B4B7CA6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3752873"/>
                </p:ext>
              </p:extLst>
            </p:nvPr>
          </p:nvGraphicFramePr>
          <p:xfrm>
            <a:off x="5963533" y="789589"/>
            <a:ext cx="2037328" cy="18949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EF2FD292-47C9-4BAB-905A-10961F7EDC56}"/>
                </a:ext>
              </a:extLst>
            </p:cNvPr>
            <p:cNvSpPr txBox="1"/>
            <p:nvPr/>
          </p:nvSpPr>
          <p:spPr>
            <a:xfrm>
              <a:off x="7077259" y="2652331"/>
              <a:ext cx="7738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rPr>
                <a:t>OLFM4</a:t>
              </a:r>
              <a:endParaRPr kumimoji="1" lang="ja-JP" altLang="en-US" sz="1400" b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00FED10B-E163-4F44-BF69-B0589B496244}"/>
                </a:ext>
              </a:extLst>
            </p:cNvPr>
            <p:cNvSpPr txBox="1"/>
            <p:nvPr/>
          </p:nvSpPr>
          <p:spPr>
            <a:xfrm>
              <a:off x="6293576" y="2544609"/>
              <a:ext cx="77389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rPr>
                <a:t>Cont. Vector</a:t>
              </a:r>
              <a:endParaRPr kumimoji="1" lang="ja-JP" altLang="en-US" sz="1400" b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CDB4ACF6-4E7A-4978-BA66-147D8A522BAD}"/>
              </a:ext>
            </a:extLst>
          </p:cNvPr>
          <p:cNvGrpSpPr/>
          <p:nvPr/>
        </p:nvGrpSpPr>
        <p:grpSpPr>
          <a:xfrm>
            <a:off x="1135240" y="5493232"/>
            <a:ext cx="1876680" cy="2469765"/>
            <a:chOff x="3928120" y="568776"/>
            <a:chExt cx="1876680" cy="2469765"/>
          </a:xfrm>
        </p:grpSpPr>
        <p:sp>
          <p:nvSpPr>
            <p:cNvPr id="157" name="テキスト ボックス 5">
              <a:extLst>
                <a:ext uri="{FF2B5EF4-FFF2-40B4-BE49-F238E27FC236}">
                  <a16:creationId xmlns:a16="http://schemas.microsoft.com/office/drawing/2014/main" id="{06DB953F-7BA3-423C-8303-F2B1F1955F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83068" y="568776"/>
              <a:ext cx="62228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kumimoji="1"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kumimoji="1"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 b="1" dirty="0"/>
                <a:t>KP-2</a:t>
              </a:r>
              <a:endParaRPr lang="ja-JP" altLang="en-US" sz="1800" b="1" dirty="0"/>
            </a:p>
          </p:txBody>
        </p:sp>
        <p:graphicFrame>
          <p:nvGraphicFramePr>
            <p:cNvPr id="158" name="グラフ 157">
              <a:extLst>
                <a:ext uri="{FF2B5EF4-FFF2-40B4-BE49-F238E27FC236}">
                  <a16:creationId xmlns:a16="http://schemas.microsoft.com/office/drawing/2014/main" id="{5CDC3D48-4AEE-480D-978A-9AEEA585109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88743731"/>
                </p:ext>
              </p:extLst>
            </p:nvPr>
          </p:nvGraphicFramePr>
          <p:xfrm>
            <a:off x="3928120" y="710215"/>
            <a:ext cx="1876680" cy="21868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83F688A9-122A-4EC7-AD11-BC2826FC2C90}"/>
                </a:ext>
              </a:extLst>
            </p:cNvPr>
            <p:cNvSpPr txBox="1"/>
            <p:nvPr/>
          </p:nvSpPr>
          <p:spPr>
            <a:xfrm>
              <a:off x="4994211" y="2623043"/>
              <a:ext cx="7738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rPr>
                <a:t>OLFM4</a:t>
              </a:r>
              <a:endParaRPr kumimoji="1" lang="ja-JP" altLang="en-US" sz="1400" b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D290C32E-D565-4CA0-A0DE-A8266B2B736F}"/>
                </a:ext>
              </a:extLst>
            </p:cNvPr>
            <p:cNvSpPr txBox="1"/>
            <p:nvPr/>
          </p:nvSpPr>
          <p:spPr>
            <a:xfrm>
              <a:off x="4256248" y="2515321"/>
              <a:ext cx="77389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rPr>
                <a:t>Cont. Vector</a:t>
              </a:r>
              <a:endParaRPr kumimoji="1" lang="ja-JP" altLang="en-US" sz="1400" b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85E59E64-98D4-4CE6-88BA-6111017303EB}"/>
              </a:ext>
            </a:extLst>
          </p:cNvPr>
          <p:cNvSpPr txBox="1"/>
          <p:nvPr/>
        </p:nvSpPr>
        <p:spPr>
          <a:xfrm>
            <a:off x="5116897" y="5862564"/>
            <a:ext cx="1177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r>
              <a:rPr lang="en-US" altLang="ja-JP" sz="1400" b="1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 &lt; 0.01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65F8B600-F98D-46C0-9987-922BB78C59B9}"/>
              </a:ext>
            </a:extLst>
          </p:cNvPr>
          <p:cNvSpPr txBox="1"/>
          <p:nvPr/>
        </p:nvSpPr>
        <p:spPr>
          <a:xfrm>
            <a:off x="4342288" y="5924120"/>
            <a:ext cx="2961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/>
              <a:t>*</a:t>
            </a:r>
            <a:endParaRPr lang="ja-JP" altLang="en-US" sz="2400" dirty="0"/>
          </a:p>
        </p:txBody>
      </p: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55AD6134-E21B-46B8-A6AD-AECD07A2CD5F}"/>
              </a:ext>
            </a:extLst>
          </p:cNvPr>
          <p:cNvCxnSpPr>
            <a:cxnSpLocks/>
          </p:cNvCxnSpPr>
          <p:nvPr/>
        </p:nvCxnSpPr>
        <p:spPr>
          <a:xfrm>
            <a:off x="4119884" y="6143458"/>
            <a:ext cx="7574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B9808EB6-EE66-4EDA-8549-9322ABCE7D92}"/>
              </a:ext>
            </a:extLst>
          </p:cNvPr>
          <p:cNvSpPr txBox="1"/>
          <p:nvPr/>
        </p:nvSpPr>
        <p:spPr>
          <a:xfrm>
            <a:off x="793710" y="5202375"/>
            <a:ext cx="34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3BB99D01-BB4E-4714-A361-262A24CD0249}"/>
              </a:ext>
            </a:extLst>
          </p:cNvPr>
          <p:cNvSpPr txBox="1"/>
          <p:nvPr/>
        </p:nvSpPr>
        <p:spPr>
          <a:xfrm>
            <a:off x="6355551" y="5234561"/>
            <a:ext cx="34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166" name="グラフ 165">
            <a:extLst>
              <a:ext uri="{FF2B5EF4-FFF2-40B4-BE49-F238E27FC236}">
                <a16:creationId xmlns:a16="http://schemas.microsoft.com/office/drawing/2014/main" id="{CE5DABBC-DED9-41BA-A444-D309F5BB23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7552490"/>
              </p:ext>
            </p:extLst>
          </p:nvPr>
        </p:nvGraphicFramePr>
        <p:xfrm>
          <a:off x="2866740" y="1617107"/>
          <a:ext cx="5677525" cy="3277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60A2A17D-3FF4-4E5D-B8A5-DCAFB98C7907}"/>
              </a:ext>
            </a:extLst>
          </p:cNvPr>
          <p:cNvSpPr txBox="1"/>
          <p:nvPr/>
        </p:nvSpPr>
        <p:spPr>
          <a:xfrm>
            <a:off x="2588280" y="1617107"/>
            <a:ext cx="341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9473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</TotalTime>
  <Words>178</Words>
  <Application>Microsoft Office PowerPoint</Application>
  <PresentationFormat>ユーザー設定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taro Ohkuma</dc:creator>
  <cp:lastModifiedBy>Ohkuma Ryotaro</cp:lastModifiedBy>
  <cp:revision>70</cp:revision>
  <dcterms:created xsi:type="dcterms:W3CDTF">2018-11-02T17:24:25Z</dcterms:created>
  <dcterms:modified xsi:type="dcterms:W3CDTF">2019-11-14T11:00:32Z</dcterms:modified>
</cp:coreProperties>
</file>